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6" autoAdjust="0"/>
    <p:restoredTop sz="94660"/>
  </p:normalViewPr>
  <p:slideViewPr>
    <p:cSldViewPr snapToGrid="0">
      <p:cViewPr varScale="1">
        <p:scale>
          <a:sx n="83" d="100"/>
          <a:sy n="83" d="100"/>
        </p:scale>
        <p:origin x="552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hmed Sallam" userId="c0f5480f-e077-4e49-9753-0058681f53f0" providerId="ADAL" clId="{89873D7B-58ED-4272-98C8-5E8230A84F02}"/>
    <pc:docChg chg="modSld">
      <pc:chgData name="Ahmed Sallam" userId="c0f5480f-e077-4e49-9753-0058681f53f0" providerId="ADAL" clId="{89873D7B-58ED-4272-98C8-5E8230A84F02}" dt="2022-05-06T14:03:31.775" v="0" actId="14100"/>
      <pc:docMkLst>
        <pc:docMk/>
      </pc:docMkLst>
      <pc:sldChg chg="modSp mod">
        <pc:chgData name="Ahmed Sallam" userId="c0f5480f-e077-4e49-9753-0058681f53f0" providerId="ADAL" clId="{89873D7B-58ED-4272-98C8-5E8230A84F02}" dt="2022-05-06T14:03:31.775" v="0" actId="14100"/>
        <pc:sldMkLst>
          <pc:docMk/>
          <pc:sldMk cId="1255043579" sldId="256"/>
        </pc:sldMkLst>
        <pc:picChg chg="mod">
          <ac:chgData name="Ahmed Sallam" userId="c0f5480f-e077-4e49-9753-0058681f53f0" providerId="ADAL" clId="{89873D7B-58ED-4272-98C8-5E8230A84F02}" dt="2022-05-06T14:03:31.775" v="0" actId="14100"/>
          <ac:picMkLst>
            <pc:docMk/>
            <pc:sldMk cId="1255043579" sldId="256"/>
            <ac:picMk id="5" creationId="{00000000-0000-0000-0000-00000000000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706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124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800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200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263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445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318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177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3701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650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E82210-40A2-45B8-9E20-99C487F46040}" type="datetimeFigureOut">
              <a:rPr lang="en-US" smtClean="0"/>
              <a:t>2022-06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C69635-F70A-4B5D-A43C-1C7BBF80AB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008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07EC2C6-4C08-45AE-A40F-E2A95E43EE8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01" t="306" r="20502" b="11110"/>
          <a:stretch/>
        </p:blipFill>
        <p:spPr>
          <a:xfrm>
            <a:off x="8592716" y="95758"/>
            <a:ext cx="3574111" cy="411276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35" t="3238" r="17327" b="5919"/>
          <a:stretch/>
        </p:blipFill>
        <p:spPr>
          <a:xfrm>
            <a:off x="175259" y="307813"/>
            <a:ext cx="3865364" cy="410891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17" r="17367" b="2960"/>
          <a:stretch/>
        </p:blipFill>
        <p:spPr>
          <a:xfrm>
            <a:off x="4051931" y="84564"/>
            <a:ext cx="4027177" cy="444871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0480" y="0"/>
            <a:ext cx="7162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068573" y="46203"/>
            <a:ext cx="7162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D19DD40-BACD-4DDF-8E43-6D1981FCF2E4}"/>
              </a:ext>
            </a:extLst>
          </p:cNvPr>
          <p:cNvSpPr txBox="1"/>
          <p:nvPr/>
        </p:nvSpPr>
        <p:spPr>
          <a:xfrm>
            <a:off x="175260" y="6032036"/>
            <a:ext cx="117805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4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Figure S1. Linkage disequilibrium between each pair of significant SNPs located on chromosome 2H (</a:t>
            </a:r>
            <a:r>
              <a:rPr lang="en-US" sz="2400" b="1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24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), 7H (</a:t>
            </a:r>
            <a:r>
              <a:rPr lang="en-US" sz="2400" b="1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24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) and 4H (</a:t>
            </a:r>
            <a:r>
              <a:rPr lang="en-US" sz="2400" b="1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24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413106" y="18303"/>
            <a:ext cx="7162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02164B77-45CB-4365-ABD2-3890F082AF6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190" t="84053" r="14839"/>
          <a:stretch/>
        </p:blipFill>
        <p:spPr>
          <a:xfrm>
            <a:off x="9463385" y="3980586"/>
            <a:ext cx="2020948" cy="731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5043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ra mourad</dc:creator>
  <cp:lastModifiedBy>MDPI-89</cp:lastModifiedBy>
  <cp:revision>6</cp:revision>
  <dcterms:created xsi:type="dcterms:W3CDTF">2021-01-28T10:35:41Z</dcterms:created>
  <dcterms:modified xsi:type="dcterms:W3CDTF">2022-06-16T11:08:09Z</dcterms:modified>
</cp:coreProperties>
</file>